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451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E8213-7FBB-4A86-96D2-DEFB1F46A82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B117F-49AE-44E1-B3FE-F5E46C063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784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E8213-7FBB-4A86-96D2-DEFB1F46A82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B117F-49AE-44E1-B3FE-F5E46C063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597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E8213-7FBB-4A86-96D2-DEFB1F46A82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B117F-49AE-44E1-B3FE-F5E46C063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593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E8213-7FBB-4A86-96D2-DEFB1F46A82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B117F-49AE-44E1-B3FE-F5E46C063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0381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E8213-7FBB-4A86-96D2-DEFB1F46A82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B117F-49AE-44E1-B3FE-F5E46C063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8651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E8213-7FBB-4A86-96D2-DEFB1F46A82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B117F-49AE-44E1-B3FE-F5E46C063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986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E8213-7FBB-4A86-96D2-DEFB1F46A82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B117F-49AE-44E1-B3FE-F5E46C063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696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E8213-7FBB-4A86-96D2-DEFB1F46A82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B117F-49AE-44E1-B3FE-F5E46C063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193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E8213-7FBB-4A86-96D2-DEFB1F46A82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B117F-49AE-44E1-B3FE-F5E46C063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753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E8213-7FBB-4A86-96D2-DEFB1F46A82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B117F-49AE-44E1-B3FE-F5E46C063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102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E8213-7FBB-4A86-96D2-DEFB1F46A82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B117F-49AE-44E1-B3FE-F5E46C063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334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9E8213-7FBB-4A86-96D2-DEFB1F46A82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2B117F-49AE-44E1-B3FE-F5E46C063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608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1800" y="3721048"/>
            <a:ext cx="4628325" cy="3063348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2010" y="3701411"/>
            <a:ext cx="4451626" cy="315658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5617" y="618800"/>
            <a:ext cx="4760292" cy="343976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3146" y="723847"/>
            <a:ext cx="4555908" cy="3292077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4526849" y="130441"/>
            <a:ext cx="3877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/>
              <a:t>Suppl. </a:t>
            </a:r>
            <a:r>
              <a:rPr lang="en-US" b="1" u="sng"/>
              <a:t>Figure </a:t>
            </a:r>
            <a:r>
              <a:rPr lang="en-US" b="1" u="sng" dirty="0"/>
              <a:t>6</a:t>
            </a:r>
            <a:r>
              <a:rPr lang="en-US" b="1" smtClean="0"/>
              <a:t>. </a:t>
            </a:r>
            <a:r>
              <a:rPr lang="en-US" b="1" dirty="0" smtClean="0"/>
              <a:t>Volcano plots for </a:t>
            </a:r>
            <a:r>
              <a:rPr lang="en-US" b="1" dirty="0" err="1" smtClean="0"/>
              <a:t>tRNA</a:t>
            </a:r>
            <a:endParaRPr lang="en-US" b="1" dirty="0"/>
          </a:p>
        </p:txBody>
      </p:sp>
      <p:sp>
        <p:nvSpPr>
          <p:cNvPr id="2" name="Rectangle 1"/>
          <p:cNvSpPr/>
          <p:nvPr/>
        </p:nvSpPr>
        <p:spPr>
          <a:xfrm>
            <a:off x="2267344" y="723847"/>
            <a:ext cx="323999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Non-smokers vs. Cigarette smokers</a:t>
            </a:r>
          </a:p>
        </p:txBody>
      </p:sp>
      <p:sp>
        <p:nvSpPr>
          <p:cNvPr id="12" name="Rectangle 11"/>
          <p:cNvSpPr/>
          <p:nvPr/>
        </p:nvSpPr>
        <p:spPr>
          <a:xfrm>
            <a:off x="1837806" y="662292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3" name="Rectangle 12"/>
          <p:cNvSpPr/>
          <p:nvPr/>
        </p:nvSpPr>
        <p:spPr>
          <a:xfrm>
            <a:off x="6841930" y="662292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4" name="Rectangle 13"/>
          <p:cNvSpPr/>
          <p:nvPr/>
        </p:nvSpPr>
        <p:spPr>
          <a:xfrm>
            <a:off x="7257428" y="696925"/>
            <a:ext cx="332308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Non-smokers vs. </a:t>
            </a:r>
            <a:r>
              <a:rPr lang="en-US" sz="14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Waterpipe</a:t>
            </a:r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 smokers</a:t>
            </a:r>
          </a:p>
        </p:txBody>
      </p:sp>
      <p:sp>
        <p:nvSpPr>
          <p:cNvPr id="15" name="Rectangle 14"/>
          <p:cNvSpPr/>
          <p:nvPr/>
        </p:nvSpPr>
        <p:spPr>
          <a:xfrm flipH="1">
            <a:off x="1837806" y="3721048"/>
            <a:ext cx="58189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16" name="Rectangle 15"/>
          <p:cNvSpPr/>
          <p:nvPr/>
        </p:nvSpPr>
        <p:spPr>
          <a:xfrm>
            <a:off x="2489051" y="3756701"/>
            <a:ext cx="26420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Non-smokers vs. E-cig users</a:t>
            </a:r>
          </a:p>
        </p:txBody>
      </p:sp>
      <p:sp>
        <p:nvSpPr>
          <p:cNvPr id="17" name="Rectangle 16"/>
          <p:cNvSpPr/>
          <p:nvPr/>
        </p:nvSpPr>
        <p:spPr>
          <a:xfrm>
            <a:off x="7022924" y="3689232"/>
            <a:ext cx="3863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D.</a:t>
            </a:r>
          </a:p>
        </p:txBody>
      </p:sp>
      <p:sp>
        <p:nvSpPr>
          <p:cNvPr id="18" name="Rectangle 17"/>
          <p:cNvSpPr/>
          <p:nvPr/>
        </p:nvSpPr>
        <p:spPr>
          <a:xfrm>
            <a:off x="7409312" y="3689232"/>
            <a:ext cx="287290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Non-smokers vs. Dual Smokers</a:t>
            </a:r>
          </a:p>
        </p:txBody>
      </p:sp>
    </p:spTree>
    <p:extLst>
      <p:ext uri="{BB962C8B-B14F-4D97-AF65-F5344CB8AC3E}">
        <p14:creationId xmlns:p14="http://schemas.microsoft.com/office/powerpoint/2010/main" val="18970472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37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R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Kameshwar</dc:creator>
  <cp:lastModifiedBy>Rahman, Irfan</cp:lastModifiedBy>
  <cp:revision>7</cp:revision>
  <dcterms:created xsi:type="dcterms:W3CDTF">2019-12-08T17:20:44Z</dcterms:created>
  <dcterms:modified xsi:type="dcterms:W3CDTF">2020-06-12T05:18:03Z</dcterms:modified>
</cp:coreProperties>
</file>